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 showGuides="1">
      <p:cViewPr varScale="1">
        <p:scale>
          <a:sx n="73" d="100"/>
          <a:sy n="73" d="100"/>
        </p:scale>
        <p:origin x="2460" y="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PT"/>
              <a:t>Clique para editar o estilo de subtítulo do Modelo Globa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CD521-0FAD-4E5B-B913-EC470371E61F}" type="datetimeFigureOut">
              <a:rPr lang="pt-PT" smtClean="0"/>
              <a:t>24/06/2025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615FA-D229-440F-8F1F-FB8B6ED4588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8768271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CD521-0FAD-4E5B-B913-EC470371E61F}" type="datetimeFigureOut">
              <a:rPr lang="pt-PT" smtClean="0"/>
              <a:t>24/06/2025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615FA-D229-440F-8F1F-FB8B6ED4588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9868081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CD521-0FAD-4E5B-B913-EC470371E61F}" type="datetimeFigureOut">
              <a:rPr lang="pt-PT" smtClean="0"/>
              <a:t>24/06/2025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615FA-D229-440F-8F1F-FB8B6ED4588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3540805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CD521-0FAD-4E5B-B913-EC470371E61F}" type="datetimeFigureOut">
              <a:rPr lang="pt-PT" smtClean="0"/>
              <a:t>24/06/2025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615FA-D229-440F-8F1F-FB8B6ED4588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5492219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CD521-0FAD-4E5B-B913-EC470371E61F}" type="datetimeFigureOut">
              <a:rPr lang="pt-PT" smtClean="0"/>
              <a:t>24/06/2025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615FA-D229-440F-8F1F-FB8B6ED4588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508492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CD521-0FAD-4E5B-B913-EC470371E61F}" type="datetimeFigureOut">
              <a:rPr lang="pt-PT" smtClean="0"/>
              <a:t>24/06/2025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615FA-D229-440F-8F1F-FB8B6ED4588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4886705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CD521-0FAD-4E5B-B913-EC470371E61F}" type="datetimeFigureOut">
              <a:rPr lang="pt-PT" smtClean="0"/>
              <a:t>24/06/2025</a:t>
            </a:fld>
            <a:endParaRPr lang="pt-P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615FA-D229-440F-8F1F-FB8B6ED4588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1088100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CD521-0FAD-4E5B-B913-EC470371E61F}" type="datetimeFigureOut">
              <a:rPr lang="pt-PT" smtClean="0"/>
              <a:t>24/06/2025</a:t>
            </a:fld>
            <a:endParaRPr lang="pt-P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615FA-D229-440F-8F1F-FB8B6ED4588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4327595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CD521-0FAD-4E5B-B913-EC470371E61F}" type="datetimeFigureOut">
              <a:rPr lang="pt-PT" smtClean="0"/>
              <a:t>24/06/2025</a:t>
            </a:fld>
            <a:endParaRPr lang="pt-P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615FA-D229-440F-8F1F-FB8B6ED4588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361812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CD521-0FAD-4E5B-B913-EC470371E61F}" type="datetimeFigureOut">
              <a:rPr lang="pt-PT" smtClean="0"/>
              <a:t>24/06/2025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615FA-D229-440F-8F1F-FB8B6ED4588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1770075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PT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CD521-0FAD-4E5B-B913-EC470371E61F}" type="datetimeFigureOut">
              <a:rPr lang="pt-PT" smtClean="0"/>
              <a:t>24/06/2025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615FA-D229-440F-8F1F-FB8B6ED4588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1325052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1CD521-0FAD-4E5B-B913-EC470371E61F}" type="datetimeFigureOut">
              <a:rPr lang="pt-PT" smtClean="0"/>
              <a:t>24/06/2025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3615FA-D229-440F-8F1F-FB8B6ED4588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2133064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officeArt object" descr="A graph of different colored squares&#10;&#10;AI-generated content may be incorrect.">
            <a:extLst>
              <a:ext uri="{FF2B5EF4-FFF2-40B4-BE49-F238E27FC236}">
                <a16:creationId xmlns:a16="http://schemas.microsoft.com/office/drawing/2014/main" id="{440E8558-CF4B-4B4A-A47C-FA7D27F9BDAB}"/>
              </a:ext>
            </a:extLst>
          </p:cNvPr>
          <p:cNvPicPr/>
          <p:nvPr/>
        </p:nvPicPr>
        <p:blipFill>
          <a:blip r:embed="rId2">
            <a:extLst/>
          </a:blip>
          <a:stretch>
            <a:fillRect/>
          </a:stretch>
        </p:blipFill>
        <p:spPr>
          <a:xfrm>
            <a:off x="1301591" y="574674"/>
            <a:ext cx="4254818" cy="4111625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  <p:sp>
        <p:nvSpPr>
          <p:cNvPr id="5" name="CaixaDeTexto 4">
            <a:extLst>
              <a:ext uri="{FF2B5EF4-FFF2-40B4-BE49-F238E27FC236}">
                <a16:creationId xmlns:a16="http://schemas.microsoft.com/office/drawing/2014/main" id="{D2534C70-04D6-4B05-A84C-E0E3BCA9310B}"/>
              </a:ext>
            </a:extLst>
          </p:cNvPr>
          <p:cNvSpPr txBox="1"/>
          <p:nvPr/>
        </p:nvSpPr>
        <p:spPr>
          <a:xfrm>
            <a:off x="1114697" y="4968240"/>
            <a:ext cx="4628605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Supplementary Figure 1.</a:t>
            </a:r>
            <a:r>
              <a:rPr lang="en-US" sz="1200" dirty="0"/>
              <a:t> Box-and-whisker plots showing qPCR Ct values of positive samples from wild boar and domestic pigs for PCV2 and PCV3. Blue and orange represent PCV2-positive samples from wild boar and domestic pigs, respectively; grey and yellow represent PCV3-positive samples from wild boar and domestic pigs, respectively. For PCV2, only three domestic pig samples were positive, limiting the strength of direct comparisons. The "×" symbol above each box plot indicates the average Ct value for each group.</a:t>
            </a:r>
            <a:endParaRPr lang="pt-PT" sz="1200" dirty="0"/>
          </a:p>
          <a:p>
            <a:pPr algn="just"/>
            <a:endParaRPr lang="pt-PT" sz="1200" dirty="0"/>
          </a:p>
        </p:txBody>
      </p:sp>
    </p:spTree>
    <p:extLst>
      <p:ext uri="{BB962C8B-B14F-4D97-AF65-F5344CB8AC3E}">
        <p14:creationId xmlns:p14="http://schemas.microsoft.com/office/powerpoint/2010/main" val="397401711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88</Words>
  <Application>Microsoft Office PowerPoint</Application>
  <PresentationFormat>Papel A4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o Office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argarida Henriques</dc:creator>
  <cp:lastModifiedBy>Margarida Henriques</cp:lastModifiedBy>
  <cp:revision>2</cp:revision>
  <dcterms:created xsi:type="dcterms:W3CDTF">2025-06-24T09:33:56Z</dcterms:created>
  <dcterms:modified xsi:type="dcterms:W3CDTF">2025-06-24T09:35:25Z</dcterms:modified>
</cp:coreProperties>
</file>